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50" y="2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98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62658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3981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9195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84743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98444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67221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1900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5693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20414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6331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884E9-6A25-4324-9E8C-CB43D997CD19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26323-146D-4CE1-B6F0-10E9A18A446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76242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234" y="4317528"/>
            <a:ext cx="3470148" cy="16002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53" y="483632"/>
            <a:ext cx="4669536" cy="325678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71512" y="160133"/>
            <a:ext cx="414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 supplement 1</a:t>
            </a:r>
            <a:endParaRPr lang="en-AU" dirty="0"/>
          </a:p>
        </p:txBody>
      </p:sp>
      <p:sp>
        <p:nvSpPr>
          <p:cNvPr id="10" name="TextBox 9"/>
          <p:cNvSpPr txBox="1"/>
          <p:nvPr/>
        </p:nvSpPr>
        <p:spPr>
          <a:xfrm>
            <a:off x="4851272" y="827377"/>
            <a:ext cx="33307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Unrelated experiment –  AMPK activator dose response in primary cells</a:t>
            </a:r>
            <a:endParaRPr lang="en-AU" dirty="0"/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4324350" y="1190625"/>
            <a:ext cx="426339" cy="76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750689" y="2322510"/>
            <a:ext cx="33307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supplement 1</a:t>
            </a:r>
          </a:p>
          <a:p>
            <a:r>
              <a:rPr lang="en-AU" dirty="0" smtClean="0"/>
              <a:t>pT172 in hypothalamus lysates from wild type and ACC DKI mice</a:t>
            </a:r>
            <a:endParaRPr lang="en-AU" dirty="0"/>
          </a:p>
        </p:txBody>
      </p:sp>
      <p:sp>
        <p:nvSpPr>
          <p:cNvPr id="14" name="Rectangle 13"/>
          <p:cNvSpPr/>
          <p:nvPr/>
        </p:nvSpPr>
        <p:spPr>
          <a:xfrm>
            <a:off x="1304925" y="2591360"/>
            <a:ext cx="1438275" cy="4185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4195382" y="2669882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688437" y="4336245"/>
            <a:ext cx="33307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Unrelated experiment –  AMPK activator dose response in primary cells</a:t>
            </a:r>
            <a:endParaRPr lang="en-AU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4161515" y="4699493"/>
            <a:ext cx="426339" cy="76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720464" y="5343071"/>
            <a:ext cx="33307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supplement 1</a:t>
            </a:r>
          </a:p>
          <a:p>
            <a:r>
              <a:rPr lang="en-AU" dirty="0" err="1" smtClean="0"/>
              <a:t>pACC</a:t>
            </a:r>
            <a:r>
              <a:rPr lang="en-AU" dirty="0" smtClean="0"/>
              <a:t> in hypothalamus lysates from wild type and ACC DKI mice</a:t>
            </a:r>
            <a:endParaRPr lang="en-AU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4165157" y="5690443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>
            <a:off x="881592" y="5323463"/>
            <a:ext cx="1438275" cy="4185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3253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71512" y="160133"/>
            <a:ext cx="414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 supplement 1</a:t>
            </a:r>
            <a:endParaRPr lang="en-AU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398" y="3162724"/>
            <a:ext cx="4230624" cy="290322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389022" y="3816956"/>
            <a:ext cx="33307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Unrelated experiment –  AMPK activator dose response in primary cells</a:t>
            </a:r>
            <a:endParaRPr lang="en-AU" dirty="0"/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3862100" y="4180204"/>
            <a:ext cx="426339" cy="76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421049" y="4823782"/>
            <a:ext cx="33307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supplement 1</a:t>
            </a:r>
          </a:p>
          <a:p>
            <a:r>
              <a:rPr lang="en-AU" dirty="0" smtClean="0"/>
              <a:t>ACC in hypothalamus lysates from wild type and ACC DKI mice</a:t>
            </a:r>
            <a:endParaRPr lang="en-AU" dirty="0"/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3865742" y="5171154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847020" y="4992899"/>
            <a:ext cx="1399469" cy="4185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512" y="1280021"/>
            <a:ext cx="3257550" cy="101325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288439" y="1447334"/>
            <a:ext cx="33307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supplement 1</a:t>
            </a:r>
          </a:p>
          <a:p>
            <a:r>
              <a:rPr lang="en-AU" dirty="0" smtClean="0"/>
              <a:t>AMPK pan </a:t>
            </a:r>
            <a:r>
              <a:rPr lang="el-GR" dirty="0" smtClean="0"/>
              <a:t>α</a:t>
            </a:r>
            <a:r>
              <a:rPr lang="en-AU" dirty="0" smtClean="0"/>
              <a:t> in hypothalamus lysates from wild type and ACC DKI mice</a:t>
            </a:r>
            <a:endParaRPr lang="en-AU" dirty="0"/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3733132" y="1794706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847020" y="1602310"/>
            <a:ext cx="1438275" cy="4185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" name="TextBox 13"/>
          <p:cNvSpPr txBox="1"/>
          <p:nvPr/>
        </p:nvSpPr>
        <p:spPr>
          <a:xfrm>
            <a:off x="847020" y="2062854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WT</a:t>
            </a:r>
            <a:endParaRPr lang="en-AU" sz="1050" dirty="0"/>
          </a:p>
        </p:txBody>
      </p:sp>
      <p:sp>
        <p:nvSpPr>
          <p:cNvPr id="15" name="TextBox 14"/>
          <p:cNvSpPr txBox="1"/>
          <p:nvPr/>
        </p:nvSpPr>
        <p:spPr>
          <a:xfrm>
            <a:off x="1225650" y="2060883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WT</a:t>
            </a:r>
            <a:endParaRPr lang="en-AU" sz="1050" dirty="0"/>
          </a:p>
        </p:txBody>
      </p:sp>
      <p:sp>
        <p:nvSpPr>
          <p:cNvPr id="16" name="TextBox 15"/>
          <p:cNvSpPr txBox="1"/>
          <p:nvPr/>
        </p:nvSpPr>
        <p:spPr>
          <a:xfrm>
            <a:off x="1589379" y="206857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DKI</a:t>
            </a:r>
            <a:endParaRPr lang="en-AU" sz="1050" dirty="0"/>
          </a:p>
        </p:txBody>
      </p:sp>
      <p:sp>
        <p:nvSpPr>
          <p:cNvPr id="17" name="TextBox 16"/>
          <p:cNvSpPr txBox="1"/>
          <p:nvPr/>
        </p:nvSpPr>
        <p:spPr>
          <a:xfrm>
            <a:off x="1921758" y="2062969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DKI</a:t>
            </a:r>
            <a:endParaRPr lang="en-AU" sz="1050" dirty="0"/>
          </a:p>
        </p:txBody>
      </p:sp>
      <p:sp>
        <p:nvSpPr>
          <p:cNvPr id="19" name="TextBox 18"/>
          <p:cNvSpPr txBox="1"/>
          <p:nvPr/>
        </p:nvSpPr>
        <p:spPr>
          <a:xfrm>
            <a:off x="2189099" y="2057094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WT</a:t>
            </a:r>
            <a:endParaRPr lang="en-AU" sz="1050" dirty="0"/>
          </a:p>
        </p:txBody>
      </p:sp>
      <p:sp>
        <p:nvSpPr>
          <p:cNvPr id="20" name="TextBox 19"/>
          <p:cNvSpPr txBox="1"/>
          <p:nvPr/>
        </p:nvSpPr>
        <p:spPr>
          <a:xfrm>
            <a:off x="2567729" y="2055123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WT</a:t>
            </a:r>
            <a:endParaRPr lang="en-AU" sz="1050" dirty="0"/>
          </a:p>
        </p:txBody>
      </p:sp>
      <p:sp>
        <p:nvSpPr>
          <p:cNvPr id="21" name="TextBox 20"/>
          <p:cNvSpPr txBox="1"/>
          <p:nvPr/>
        </p:nvSpPr>
        <p:spPr>
          <a:xfrm>
            <a:off x="2931458" y="206281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DKI</a:t>
            </a:r>
            <a:endParaRPr lang="en-AU" sz="1050" dirty="0"/>
          </a:p>
        </p:txBody>
      </p:sp>
      <p:sp>
        <p:nvSpPr>
          <p:cNvPr id="22" name="TextBox 21"/>
          <p:cNvSpPr txBox="1"/>
          <p:nvPr/>
        </p:nvSpPr>
        <p:spPr>
          <a:xfrm>
            <a:off x="3263837" y="2057209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smtClean="0"/>
              <a:t>DKI</a:t>
            </a:r>
            <a:endParaRPr lang="en-AU" sz="1050" dirty="0"/>
          </a:p>
        </p:txBody>
      </p:sp>
    </p:spTree>
    <p:extLst>
      <p:ext uri="{BB962C8B-B14F-4D97-AF65-F5344CB8AC3E}">
        <p14:creationId xmlns:p14="http://schemas.microsoft.com/office/powerpoint/2010/main" val="2068792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535" y="959358"/>
            <a:ext cx="3377184" cy="151180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71512" y="160133"/>
            <a:ext cx="414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 supplement 1</a:t>
            </a:r>
            <a:endParaRPr lang="en-AU" dirty="0"/>
          </a:p>
        </p:txBody>
      </p:sp>
      <p:sp>
        <p:nvSpPr>
          <p:cNvPr id="5" name="TextBox 4"/>
          <p:cNvSpPr txBox="1"/>
          <p:nvPr/>
        </p:nvSpPr>
        <p:spPr>
          <a:xfrm>
            <a:off x="4626512" y="3396643"/>
            <a:ext cx="279749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supplement 1</a:t>
            </a:r>
          </a:p>
          <a:p>
            <a:r>
              <a:rPr lang="en-AU" dirty="0" smtClean="0"/>
              <a:t>ACC in liver and whole brain tissue lysates</a:t>
            </a:r>
            <a:endParaRPr lang="en-AU" dirty="0"/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4071205" y="3744015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512" y="959358"/>
            <a:ext cx="3352800" cy="493928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617486" y="3592593"/>
            <a:ext cx="1304748" cy="4185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TextBox 7"/>
          <p:cNvSpPr txBox="1"/>
          <p:nvPr/>
        </p:nvSpPr>
        <p:spPr>
          <a:xfrm>
            <a:off x="8286442" y="1524609"/>
            <a:ext cx="279749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3 –supplement 1</a:t>
            </a:r>
          </a:p>
          <a:p>
            <a:r>
              <a:rPr lang="en-AU" dirty="0" smtClean="0"/>
              <a:t>ACC in skeletal muscle and hypothalamus tissue lysates</a:t>
            </a:r>
            <a:endParaRPr lang="en-AU" dirty="0"/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7731135" y="1871981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5758901" y="1453441"/>
            <a:ext cx="1251499" cy="4354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8697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</Words>
  <Application>Microsoft Office PowerPoint</Application>
  <PresentationFormat>Widescreen</PresentationFormat>
  <Paragraphs>2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University of Melbour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ra galic</dc:creator>
  <cp:lastModifiedBy>Sandra galic</cp:lastModifiedBy>
  <cp:revision>1</cp:revision>
  <dcterms:created xsi:type="dcterms:W3CDTF">2018-01-15T03:53:33Z</dcterms:created>
  <dcterms:modified xsi:type="dcterms:W3CDTF">2018-01-15T03:54:17Z</dcterms:modified>
</cp:coreProperties>
</file>